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8"/>
    <p:restoredTop sz="94626"/>
  </p:normalViewPr>
  <p:slideViewPr>
    <p:cSldViewPr snapToGrid="0">
      <p:cViewPr varScale="1">
        <p:scale>
          <a:sx n="87" d="100"/>
          <a:sy n="87" d="100"/>
        </p:scale>
        <p:origin x="34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0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476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917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116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91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810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3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86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816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11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0BEB4F-80A6-CC4B-AF1D-76384565B09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E41035-8F82-9F46-A0D0-2461CE515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437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datadryad.org/dataset/doi:10.5061/dryad.p5hqbzkxs" TargetMode="External"/><Relationship Id="rId2" Type="http://schemas.openxmlformats.org/officeDocument/2006/relationships/hyperlink" Target="https://doi.org/doi:10.5061/dryad.1vhhmgqzc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1C1A4E5-807F-7979-CE84-B079CE1EA8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9711548"/>
              </p:ext>
            </p:extLst>
          </p:nvPr>
        </p:nvGraphicFramePr>
        <p:xfrm>
          <a:off x="481575" y="501443"/>
          <a:ext cx="1765300" cy="27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65300">
                  <a:extLst>
                    <a:ext uri="{9D8B030D-6E8A-4147-A177-3AD203B41FA5}">
                      <a16:colId xmlns:a16="http://schemas.microsoft.com/office/drawing/2014/main" val="1899888948"/>
                    </a:ext>
                  </a:extLst>
                </a:gridCol>
              </a:tblGrid>
              <a:tr h="2776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BOR-2025-61534-T </a:t>
                      </a:r>
                      <a:endParaRPr lang="en-US" sz="1200" b="0" i="0" u="none" strike="noStrike" dirty="0">
                        <a:solidFill>
                          <a:srgbClr val="1F1F1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795174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585EB76-EB4F-8425-8187-65C2FEF6C581}"/>
              </a:ext>
            </a:extLst>
          </p:cNvPr>
          <p:cNvSpPr txBox="1"/>
          <p:nvPr/>
        </p:nvSpPr>
        <p:spPr>
          <a:xfrm flipH="1">
            <a:off x="437595" y="1002890"/>
            <a:ext cx="15091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EF66C35B-4137-8402-C8A3-9ADCDA10CBE7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1166646" y="2451931"/>
            <a:ext cx="4556235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availability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ata deposited in DRYAD as curated Microsoft Excel files for murine KPC cell RNA-seq data, and human PANC-1 RNA-seq data at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doi:10.5061/dryad.1vhhmgqzc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atadryad.org/dataset/doi:10.5061/dryad.p5hqbzkx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https:/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atadryad.or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dataset/doi:10.5061/dryad.1vhhmgqzc.</a:t>
            </a:r>
          </a:p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dditional information and/or reagents are available from the authors on request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D06E40-3C5E-6629-BBB7-B79F60C77D2A}"/>
              </a:ext>
            </a:extLst>
          </p:cNvPr>
          <p:cNvSpPr txBox="1"/>
          <p:nvPr/>
        </p:nvSpPr>
        <p:spPr>
          <a:xfrm>
            <a:off x="1206062" y="1915510"/>
            <a:ext cx="2502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2C based on available data</a:t>
            </a:r>
          </a:p>
        </p:txBody>
      </p:sp>
    </p:spTree>
    <p:extLst>
      <p:ext uri="{BB962C8B-B14F-4D97-AF65-F5344CB8AC3E}">
        <p14:creationId xmlns:p14="http://schemas.microsoft.com/office/powerpoint/2010/main" val="67762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94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5</cp:revision>
  <dcterms:created xsi:type="dcterms:W3CDTF">2025-06-10T17:49:13Z</dcterms:created>
  <dcterms:modified xsi:type="dcterms:W3CDTF">2025-06-10T18:29:47Z</dcterms:modified>
</cp:coreProperties>
</file>